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20000" autoAdjust="0"/>
    <p:restoredTop sz="94660"/>
  </p:normalViewPr>
  <p:slideViewPr>
    <p:cSldViewPr snapToGrid="0">
      <p:cViewPr varScale="1">
        <p:scale>
          <a:sx n="124" d="100"/>
          <a:sy n="124" d="100"/>
        </p:scale>
        <p:origin x="992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4225FFF-2B3A-4553-8BCE-B4E7788B291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F1B37BB-5A85-49D3-A89E-C5284B2A640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A09059E-5976-4FE5-87A6-CBEAD438CE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F417E-AC40-4162-BFC2-97E899657FFF}" type="datetimeFigureOut">
              <a:rPr kumimoji="1" lang="ja-JP" altLang="en-US" smtClean="0"/>
              <a:t>2021/11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E84DE55-C138-42CB-B148-84CB66F2B7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1211E6C-2611-45D4-96D2-C7590A5452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02637-F85E-4D85-9CF1-40200A1F48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74310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6F53EFC-6C7D-4FB5-A48E-D02CFBE430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77FAA9D-2146-4B91-8066-629E43327F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D21B108-1CEC-4D37-BF19-DF3CD51818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F417E-AC40-4162-BFC2-97E899657FFF}" type="datetimeFigureOut">
              <a:rPr kumimoji="1" lang="ja-JP" altLang="en-US" smtClean="0"/>
              <a:t>2021/11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EC4666D-5481-44A5-A06B-7B66769DEE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BBB437D-8DA1-48F2-82BD-BBA51B2EEA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02637-F85E-4D85-9CF1-40200A1F48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86560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B031A82-EAA5-4F60-A48D-7D4DE4E9487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B28E33D-5EF3-4E65-B9BF-A3A28FB3C7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B5CF2D5-D4F9-43D8-8B59-0A3178A67B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F417E-AC40-4162-BFC2-97E899657FFF}" type="datetimeFigureOut">
              <a:rPr kumimoji="1" lang="ja-JP" altLang="en-US" smtClean="0"/>
              <a:t>2021/11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19CDA7C-4326-4F88-B5A7-06E7F71A0D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EE5C90C-3714-4BB9-B696-CB34F9F834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02637-F85E-4D85-9CF1-40200A1F48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57924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72E5B7C-F1FF-492A-999E-85CA04BEFA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078AEB6-A054-4832-845D-E46266F15A3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6680763-1F89-4946-8BF2-02DA92BC86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F417E-AC40-4162-BFC2-97E899657FFF}" type="datetimeFigureOut">
              <a:rPr kumimoji="1" lang="ja-JP" altLang="en-US" smtClean="0"/>
              <a:t>2021/11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F64FF25-A162-4EFA-8FEE-DD82661AF2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A91CC49-AD6D-41CA-9221-06DEC51850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02637-F85E-4D85-9CF1-40200A1F48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9806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EA256C6-5223-4B1D-88D7-59290979E1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5E200C2-3420-4A44-9940-FD783CC949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BA4F104-CE2B-4ED2-BD2A-947AD5B159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F417E-AC40-4162-BFC2-97E899657FFF}" type="datetimeFigureOut">
              <a:rPr kumimoji="1" lang="ja-JP" altLang="en-US" smtClean="0"/>
              <a:t>2021/11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8632B75-B354-4C4B-AD27-A2E6D0826E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6FD514A-BAA2-40D4-8BE1-1EF42DB6AF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02637-F85E-4D85-9CF1-40200A1F48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85594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FBEDB76-A58C-4A5D-830B-3999011EEF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40A0397-7099-4940-9F24-4CD13021699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3209ADB-0679-4630-88CE-89B21FCA41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384F3F0-52DF-4573-B2FD-AAC2DD399F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F417E-AC40-4162-BFC2-97E899657FFF}" type="datetimeFigureOut">
              <a:rPr kumimoji="1" lang="ja-JP" altLang="en-US" smtClean="0"/>
              <a:t>2021/11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E5C7897-3582-4A88-80BD-30F347F8EA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337FED6-4B04-468B-9582-3C43775ECA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02637-F85E-4D85-9CF1-40200A1F48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13590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0535D89-954E-4BE0-B1A1-FFAD9E43A4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A6B6370-D92C-400D-916E-825E56E295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E0D9702-E20F-4D73-9615-45504EB955C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881DE192-C6CB-4F77-9470-B86B9A5A0BA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3EAB008F-EBFC-436D-AD9E-78C7A19C874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71D2003-F376-4623-BCEF-6A489CD017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F417E-AC40-4162-BFC2-97E899657FFF}" type="datetimeFigureOut">
              <a:rPr kumimoji="1" lang="ja-JP" altLang="en-US" smtClean="0"/>
              <a:t>2021/11/1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58ABBCD7-AB59-4BCB-B149-2CA13A2856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4B322E5E-F877-4C57-9C48-52DC168C0D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02637-F85E-4D85-9CF1-40200A1F48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62599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6CD6FC0-02E9-438C-A7FA-881426CF01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72C90C5-4D44-403B-9C8E-95FF63944A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F417E-AC40-4162-BFC2-97E899657FFF}" type="datetimeFigureOut">
              <a:rPr kumimoji="1" lang="ja-JP" altLang="en-US" smtClean="0"/>
              <a:t>2021/11/1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2D99620-3007-4768-B3A2-4C8A11D85A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D813994-860D-4031-8C04-4D70F9879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02637-F85E-4D85-9CF1-40200A1F48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76190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2D679F2-F3F3-4383-90FD-668D4C3BEA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F417E-AC40-4162-BFC2-97E899657FFF}" type="datetimeFigureOut">
              <a:rPr kumimoji="1" lang="ja-JP" altLang="en-US" smtClean="0"/>
              <a:t>2021/11/1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D710196-9AE7-49A6-AF09-1C8C457ABC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EA3E3CBD-56FE-427F-924A-1A54EA5AE6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02637-F85E-4D85-9CF1-40200A1F48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72495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7D93232-5CDD-4812-8021-6F8B25EEA3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B7E50DE-439A-4BCB-AC2A-6B97701A9A1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6208BC7-BEE3-4A4C-9737-A721A4FE7DA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6E4ADA5-A3C9-47F9-A84D-D83D9E587D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F417E-AC40-4162-BFC2-97E899657FFF}" type="datetimeFigureOut">
              <a:rPr kumimoji="1" lang="ja-JP" altLang="en-US" smtClean="0"/>
              <a:t>2021/11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2BEADCD-8618-4837-816A-DAA1D23E73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F349720-2386-4B7D-BDE3-63F416CF83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02637-F85E-4D85-9CF1-40200A1F48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21502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BFBCDB5-D251-4423-9690-470A8B178C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C06FD727-A16E-4F2C-9C2C-1736A2EEB9B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E94740F-3E8F-4816-9A31-38145744F9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390C72D-4355-48D3-BB9F-F4E1ED93C0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F417E-AC40-4162-BFC2-97E899657FFF}" type="datetimeFigureOut">
              <a:rPr kumimoji="1" lang="ja-JP" altLang="en-US" smtClean="0"/>
              <a:t>2021/11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EB630C6-1A1D-4B84-89BF-83732ECA5A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E0683B9-5CEA-479E-A6EB-7A6CADBA7B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02637-F85E-4D85-9CF1-40200A1F48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45452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68EE4BE-403B-4DF4-B88D-9FD671ED0C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8D2895A-29ED-48E6-84F6-2A848B6311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849D890-E1C0-4523-A6FA-B1C7AB250A4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5F417E-AC40-4162-BFC2-97E899657FFF}" type="datetimeFigureOut">
              <a:rPr kumimoji="1" lang="ja-JP" altLang="en-US" smtClean="0"/>
              <a:t>2021/11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9CB3444-6D26-4823-AABE-1FEC07216C0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73AEC1E-62AF-4CAB-B6AD-E6CBC714CE1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402637-F85E-4D85-9CF1-40200A1F48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50577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4CB5236A-10CB-4D1A-ADC2-1CFCC55C7ED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860" y="1820567"/>
            <a:ext cx="7415907" cy="4942702"/>
          </a:xfrm>
          <a:prstGeom prst="rect">
            <a:avLst/>
          </a:prstGeom>
        </p:spPr>
      </p:pic>
      <p:sp>
        <p:nvSpPr>
          <p:cNvPr id="2" name="テキスト ボックス 1"/>
          <p:cNvSpPr txBox="1"/>
          <p:nvPr/>
        </p:nvSpPr>
        <p:spPr>
          <a:xfrm>
            <a:off x="7521147" y="1771139"/>
            <a:ext cx="467085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Western blot analysis of prion protein. The gel mobility of prion protein from the present case is compared with those from controls with </a:t>
            </a:r>
            <a:r>
              <a:rPr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Creutzfeldt</a:t>
            </a:r>
            <a:r>
              <a:rPr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–</a:t>
            </a:r>
            <a:r>
              <a:rPr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Jakob</a:t>
            </a:r>
            <a:r>
              <a:rPr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 disease types 1 and 2.</a:t>
            </a:r>
            <a:endParaRPr kumimoji="1" lang="ja-JP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 rot="16200000">
            <a:off x="1470259" y="-352617"/>
            <a:ext cx="1194305" cy="203132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dirty="0" err="1">
                <a:latin typeface="Calibri" panose="020F0502020204030204" pitchFamily="34" charset="0"/>
                <a:ea typeface="Arial Unicode MS" panose="020B0604020202020204" pitchFamily="50" charset="-128"/>
                <a:cs typeface="Arial Unicode MS" panose="020B0604020202020204" pitchFamily="50" charset="-128"/>
              </a:rPr>
              <a:t>Mr</a:t>
            </a:r>
            <a:r>
              <a:rPr kumimoji="1" lang="en-US" altLang="ja-JP" sz="1400" dirty="0">
                <a:latin typeface="Calibri" panose="020F0502020204030204" pitchFamily="34" charset="0"/>
                <a:ea typeface="Arial Unicode MS" panose="020B0604020202020204" pitchFamily="50" charset="-128"/>
                <a:cs typeface="Arial Unicode MS" panose="020B0604020202020204" pitchFamily="50" charset="-128"/>
              </a:rPr>
              <a:t> (</a:t>
            </a:r>
            <a:r>
              <a:rPr kumimoji="1" lang="en-US" altLang="ja-JP" sz="1400" dirty="0" err="1">
                <a:latin typeface="Calibri" panose="020F0502020204030204" pitchFamily="34" charset="0"/>
                <a:ea typeface="Arial Unicode MS" panose="020B0604020202020204" pitchFamily="50" charset="-128"/>
                <a:cs typeface="Arial Unicode MS" panose="020B0604020202020204" pitchFamily="50" charset="-128"/>
              </a:rPr>
              <a:t>kDa</a:t>
            </a:r>
            <a:r>
              <a:rPr kumimoji="1" lang="en-US" altLang="ja-JP" sz="1400" dirty="0">
                <a:latin typeface="Calibri" panose="020F0502020204030204" pitchFamily="34" charset="0"/>
                <a:ea typeface="Arial Unicode MS" panose="020B0604020202020204" pitchFamily="50" charset="-128"/>
                <a:cs typeface="Arial Unicode MS" panose="020B0604020202020204" pitchFamily="50" charset="-128"/>
              </a:rPr>
              <a:t>)</a:t>
            </a:r>
          </a:p>
          <a:p>
            <a:endParaRPr lang="en-US" altLang="ja-JP" sz="1400" dirty="0">
              <a:latin typeface="Calibri" panose="020F0502020204030204" pitchFamily="34" charset="0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  <a:p>
            <a:endParaRPr lang="en-US" altLang="ja-JP" sz="1400" dirty="0">
              <a:latin typeface="Calibri" panose="020F0502020204030204" pitchFamily="34" charset="0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  <a:p>
            <a:endParaRPr kumimoji="1" lang="en-US" altLang="ja-JP" sz="1000" dirty="0">
              <a:latin typeface="Calibri" panose="020F0502020204030204" pitchFamily="34" charset="0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  <a:p>
            <a:r>
              <a:rPr kumimoji="1" lang="en-US" altLang="ja-JP" sz="1400" dirty="0">
                <a:latin typeface="Calibri" panose="020F0502020204030204" pitchFamily="34" charset="0"/>
                <a:ea typeface="Arial Unicode MS" panose="020B0604020202020204" pitchFamily="50" charset="-128"/>
                <a:cs typeface="Arial Unicode MS" panose="020B0604020202020204" pitchFamily="50" charset="-128"/>
              </a:rPr>
              <a:t>CJD type 2</a:t>
            </a:r>
          </a:p>
          <a:p>
            <a:endParaRPr lang="en-US" altLang="ja-JP" sz="1400" dirty="0">
              <a:latin typeface="Calibri" panose="020F0502020204030204" pitchFamily="34" charset="0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  <a:p>
            <a:r>
              <a:rPr lang="en-US" altLang="ja-JP" sz="1400" dirty="0">
                <a:latin typeface="Calibri" panose="020F0502020204030204" pitchFamily="34" charset="0"/>
                <a:ea typeface="Arial Unicode MS" panose="020B0604020202020204" pitchFamily="50" charset="-128"/>
                <a:cs typeface="Arial Unicode MS" panose="020B0604020202020204" pitchFamily="50" charset="-128"/>
              </a:rPr>
              <a:t>Present case</a:t>
            </a:r>
          </a:p>
          <a:p>
            <a:endParaRPr kumimoji="1" lang="en-US" altLang="ja-JP" sz="1400" dirty="0">
              <a:latin typeface="Calibri" panose="020F0502020204030204" pitchFamily="34" charset="0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  <a:p>
            <a:r>
              <a:rPr kumimoji="1" lang="en-US" altLang="ja-JP" sz="1400" dirty="0">
                <a:latin typeface="Calibri" panose="020F0502020204030204" pitchFamily="34" charset="0"/>
                <a:ea typeface="Arial Unicode MS" panose="020B0604020202020204" pitchFamily="50" charset="-128"/>
                <a:cs typeface="Arial Unicode MS" panose="020B0604020202020204" pitchFamily="50" charset="-128"/>
              </a:rPr>
              <a:t>CJD type 1</a:t>
            </a:r>
            <a:endParaRPr kumimoji="1" lang="ja-JP" altLang="en-US" sz="1400" dirty="0">
              <a:latin typeface="Calibri" panose="020F0502020204030204" pitchFamily="34" charset="0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8" name="下矢印 7"/>
          <p:cNvSpPr/>
          <p:nvPr/>
        </p:nvSpPr>
        <p:spPr>
          <a:xfrm>
            <a:off x="1145060" y="1268628"/>
            <a:ext cx="115330" cy="49427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下矢印 8"/>
          <p:cNvSpPr/>
          <p:nvPr/>
        </p:nvSpPr>
        <p:spPr>
          <a:xfrm>
            <a:off x="1931774" y="1268628"/>
            <a:ext cx="115330" cy="49427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下矢印 9"/>
          <p:cNvSpPr/>
          <p:nvPr/>
        </p:nvSpPr>
        <p:spPr>
          <a:xfrm>
            <a:off x="2364260" y="1268628"/>
            <a:ext cx="115330" cy="49427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下矢印 10"/>
          <p:cNvSpPr/>
          <p:nvPr/>
        </p:nvSpPr>
        <p:spPr>
          <a:xfrm>
            <a:off x="2788509" y="1268628"/>
            <a:ext cx="115330" cy="49427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71793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</TotalTime>
  <Words>45</Words>
  <Application>Microsoft Macintosh PowerPoint</Application>
  <PresentationFormat>ワイド画面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itamoto</dc:creator>
  <cp:lastModifiedBy>松原　知康</cp:lastModifiedBy>
  <cp:revision>4</cp:revision>
  <dcterms:created xsi:type="dcterms:W3CDTF">2021-11-08T01:04:43Z</dcterms:created>
  <dcterms:modified xsi:type="dcterms:W3CDTF">2021-11-13T03:40:18Z</dcterms:modified>
</cp:coreProperties>
</file>